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ETT-1</a:t>
            </a:r>
            <a:endParaRPr lang="en-US" dirty="0"/>
          </a:p>
          <a:p>
            <a:endParaRPr lang="en-US" dirty="0"/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TT-1  demonstrated gain of chromosome 5 but also showed reduced probe intensities consistent with low-level loss corresponding to 3`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PCAT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5`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ER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and all intervening gen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61188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 descr="image00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6800" y="76200"/>
            <a:ext cx="7831531" cy="4610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228600" y="304800"/>
            <a:ext cx="2514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TT-1</a:t>
            </a:r>
          </a:p>
        </p:txBody>
      </p:sp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" y="4816872"/>
            <a:ext cx="8991600" cy="9766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4" name="Straight Connector 3"/>
          <p:cNvCxnSpPr/>
          <p:nvPr/>
        </p:nvCxnSpPr>
        <p:spPr>
          <a:xfrm>
            <a:off x="3886200" y="1206558"/>
            <a:ext cx="4343400" cy="0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909435" y="519276"/>
            <a:ext cx="4320165" cy="0"/>
          </a:xfrm>
          <a:prstGeom prst="line">
            <a:avLst/>
          </a:prstGeom>
          <a:ln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Rectangle 10"/>
          <p:cNvSpPr/>
          <p:nvPr/>
        </p:nvSpPr>
        <p:spPr>
          <a:xfrm>
            <a:off x="76200" y="5733871"/>
            <a:ext cx="9067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1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ETT-1.  ETT-1  demonstrated gain of chromosome 5 but also showed reduced probe intensities consistent with low-level loss corresponding to 3` </a:t>
            </a:r>
            <a:r>
              <a:rPr lang="en-US" i="1" dirty="0"/>
              <a:t>LPCAT1</a:t>
            </a:r>
            <a:r>
              <a:rPr lang="en-US" dirty="0"/>
              <a:t>, 5` </a:t>
            </a:r>
            <a:r>
              <a:rPr lang="en-US" i="1" dirty="0"/>
              <a:t>TERT</a:t>
            </a:r>
            <a:r>
              <a:rPr lang="en-US" dirty="0"/>
              <a:t>, and all intervening genes</a:t>
            </a:r>
          </a:p>
        </p:txBody>
      </p:sp>
    </p:spTree>
    <p:extLst>
      <p:ext uri="{BB962C8B-B14F-4D97-AF65-F5344CB8AC3E}">
        <p14:creationId xmlns:p14="http://schemas.microsoft.com/office/powerpoint/2010/main" val="483790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0</TotalTime>
  <Words>104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17</cp:revision>
  <dcterms:created xsi:type="dcterms:W3CDTF">2019-10-11T15:47:09Z</dcterms:created>
  <dcterms:modified xsi:type="dcterms:W3CDTF">2021-05-15T05:14:04Z</dcterms:modified>
</cp:coreProperties>
</file>